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756"/>
    <p:restoredTop sz="94646"/>
  </p:normalViewPr>
  <p:slideViewPr>
    <p:cSldViewPr snapToGrid="0" snapToObjects="1">
      <p:cViewPr varScale="1">
        <p:scale>
          <a:sx n="105" d="100"/>
          <a:sy n="105" d="100"/>
        </p:scale>
        <p:origin x="11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020A8-B3DC-8942-A772-CE23E0FD8D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838B94-5444-1E45-8C52-AD033EB0B0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D7536B-7CB6-B24F-AFCB-5B17BD864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F8EB8B-7A2E-F844-B85F-B9EE3D7B9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F921BF-6878-914D-BA6F-68B23D3D3C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53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437F9C-18E3-5A4D-86EB-D013036021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C04B12-80AF-B143-9DD3-B790FE85C9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F0FE03-A094-4045-AA17-54E28D0E1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45D9C4-E51F-B64B-B017-40CEA78118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E32E4C-E650-AE48-A8C7-B2DF5708F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577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24414B-A287-4748-9BEC-B15CBAF6FB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EFE527-66AB-774F-B20F-F40E7D507F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DA961-EBF7-5045-B24F-692DA6B96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41B4CF-B63F-FB4C-B8E2-0672B22E6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3EFD51-246C-8F4F-A565-4D520DA21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403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CF194F-7163-EB4C-82F6-AE829372E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234E6C-C6A9-7246-9946-0351F8E5F4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77C10C-BE62-814F-BE68-C0C5325A5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369A57-CDCC-2740-AF8F-E4A090CF7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CAD33-B7E5-0743-8C9A-049B22176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84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DFFA8-180F-1341-AE64-F69A6CB3C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084D33-B863-4940-8D94-AC9A604B7A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71AC0D-120E-5E49-99EC-F590C0361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901F6-7C42-7B4B-A8EB-17CE01ADA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3D7752-EC85-E243-AF97-AE3285CE3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496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EF631-E585-0543-BDDF-119530C7DA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572FE4-35C5-6846-817B-482A974F14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AA6C08-BF08-AE42-913E-320739AB43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8C221-EC4C-854D-AA04-970687A14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7A4C17-B96B-0D40-BE3F-9934D987E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06F1A7-B735-214B-91EA-0293143AB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865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A7FE40-171B-A647-AB77-0D93260FB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9559C2-A981-C64C-9642-20AAF53CF2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FF1C71-0208-2D4C-9D4C-E2F68CDCEA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05E3A1-2F95-964E-9B79-9F5B27F392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3CFFCA-682A-6C46-8CF0-D09C7F6522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93B282-7D18-FE47-B900-80720F383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4E1033-4F90-8C41-9D81-6E6A0C61A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378B02-E687-3940-9446-233625914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00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5CE02E-8C17-3A43-9DA1-38C730AE13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6A568C-4BDB-854E-AF6C-9149B5844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9DD9FF-5307-DA4F-973A-C74693A00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5532E1-60CE-4B48-817C-ADC3A234F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078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FF9422-894A-224F-847B-51E5D7748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246F12-9264-8D48-AEB9-AD31C9B85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2C559D-879F-8748-9210-945D6ECF2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134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4754A-7439-C648-8656-EC90FB5C1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7FBCC7-E942-F647-8FF7-CF8A37C650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A9DC578-F164-3648-B53E-16FBCF43E4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115758-B2D2-A247-AB4C-B54457E2A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FD189F-4746-1045-87FF-83F1A4893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D257DC-6DF7-E644-9FEC-E58FA3D89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322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626BD-2BFB-F546-85F0-8D06DF752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E07551-2E82-8A4E-906D-96F79C88BA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117AA7-953F-244B-A4B7-DA9FE5593C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2CD0BF-296E-7F48-B593-674572158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8FB0A2-CD32-8F41-A75D-015F58D7F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8B33DA-6F97-2941-A1A9-42F810F8E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44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66BA5B-C00B-7D45-993B-7DE11BC69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255A6D-D5E5-1B4E-AD72-7C0D42C51E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5140A-4499-2C49-AAB9-8EE74C7677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24E538-B05C-244A-9F0D-2976A2944742}" type="datetimeFigureOut">
              <a:rPr lang="en-US" smtClean="0"/>
              <a:t>10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3E1538-D11C-BE46-B41D-077F2B4E2A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05D61F-8874-4D40-8166-A6FC58BD14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E0B0A-AEA6-A247-9AF7-2BE984F72E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044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9CACFCD-6E23-B84A-BDB5-8B88542C1B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eting 1 Question Bank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C8657947-C007-AE47-ABFB-61EFFACDFD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your clinical practice, what is the prevalence of patients with treatment-resistant depression in Egypt?</a:t>
            </a:r>
          </a:p>
          <a:p>
            <a:pPr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 do you diagnose treatment-resistant depression (TRD)? When do you consider it a TRD?</a:t>
            </a:r>
          </a:p>
          <a:p>
            <a:pPr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reatment-resistant patients, what tools and/or scales do you use to assess the disease?</a:t>
            </a:r>
          </a:p>
          <a:p>
            <a:pPr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at management plan (strategy) do you use for your patient? What are the factors or unmet needs that guide your selection of a management strategy?</a:t>
            </a:r>
          </a:p>
          <a:p>
            <a:pPr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an economic point of view, how does electroconvulsive therapy compare to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ketami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?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your clinical practice, how do you manage treatment-resistant depression (TRD) in the following cases? </a:t>
            </a:r>
          </a:p>
          <a:p>
            <a:pPr>
              <a:buFont typeface="Wingdings" pitchFamily="2" charset="2"/>
              <a:buChar char="ü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ve patients           </a:t>
            </a:r>
          </a:p>
          <a:p>
            <a:pPr>
              <a:buFont typeface="Wingdings" pitchFamily="2" charset="2"/>
              <a:buChar char="ü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psychotic features</a:t>
            </a:r>
          </a:p>
          <a:p>
            <a:pPr>
              <a:buFont typeface="Wingdings" pitchFamily="2" charset="2"/>
              <a:buChar char="ü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gnancy</a:t>
            </a:r>
          </a:p>
          <a:p>
            <a:pPr>
              <a:buFont typeface="+mj-lt"/>
              <a:buAutoNum type="arabicPeriod"/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389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0D292-87A8-574E-A503-2462E4A97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45592" y="246888"/>
            <a:ext cx="10515600" cy="309944"/>
          </a:xfrm>
        </p:spPr>
        <p:txBody>
          <a:bodyPr>
            <a:norm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eting 2 Question Bank</a:t>
            </a:r>
            <a:endParaRPr lang="en-US" sz="12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400B33-294A-294E-9C76-E0BE797042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45592" y="685249"/>
            <a:ext cx="10515600" cy="4943074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- What is the prevalence of TRD in your clinic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2-Why is there such a variation? Is there a demographic or socio-economic reason behind such figures? Is 5% too low or 40% too high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3-What are the age groups and gender of the patients from question 1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4: There was a variation with regard to gender, with some reports of 2:1 male to female ratio in some cases. Why there is such a variation? Are there gender-related factors that influence this variation? Is TRD viewed as a stigma in certain areas, but not in others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5: What are the criteria/tools you use when assessing TRD in patients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6-Is there a consensus on the tools and criteria used to assess a patient? Do results between these aforementioned tools vary significantly? What are the pros and cons of each tool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7- Based on your practice, please suggest an algorithm for treating TRD. (Note: The algorithm should start with a patient with MDD until s/he fails and becomes a TRD-resistant patient.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9-Based on your clinical practice, when is the patient labeled as TRD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0-Do certain medication have higher probability of treatment failure? Which medications give the best results? Are there patient-related behavior that can lead to treatment failure? How to guarantee that the patient is properly taking the medication? 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1-</a:t>
            </a:r>
            <a:r>
              <a: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sed on your practice, what are the strategies to address TRD?</a:t>
            </a:r>
          </a:p>
          <a:p>
            <a:pPr marL="0" indent="0">
              <a:buNone/>
            </a:pPr>
            <a:r>
              <a: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12- Among augmentation, maximization, combination and substitution, is there one strategy best for the Egyptian TRD patient? Is there a preference towards a certain strategy?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3-Based on your practice, what are the strategies to address TRD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4- Among augmentation, maximization, combination and substitution, is there one strategy best for the Egyptian TRD patient? Is there a preference towards a certain strategy? 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5-Based on your practice, which strategy is best for the management of TRD patients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6-What makes these strategies ideal for TRD? Can we expand on the combination part? What are the best combination for your patients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7-What are the available options after exhausting all treatment algorithms and why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8-Can you please elaborate how these options help? Are there any other options that can be added to the above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19-</a:t>
            </a:r>
            <a:r>
              <a: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at are your suggestions for other practicing psychiatrists in Egypt?</a:t>
            </a:r>
          </a:p>
          <a:p>
            <a:pPr marL="0" indent="0">
              <a:buNone/>
            </a:pP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20-</a:t>
            </a:r>
            <a:r>
              <a: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st wise, are they close in overall costs? Which is the best option from your point of view? Would you encourage your patient to take one over the other?</a:t>
            </a:r>
          </a:p>
          <a:p>
            <a:pPr marL="0" indent="0">
              <a:buNone/>
            </a:pP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37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587</Words>
  <Application>Microsoft Office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Wingdings</vt:lpstr>
      <vt:lpstr>Office Theme</vt:lpstr>
      <vt:lpstr>Meeting 1 Question Bank</vt:lpstr>
      <vt:lpstr>Meeting 2 Question Bank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eting 1 Question Bank</dc:title>
  <dc:creator>Microsoft Office User</dc:creator>
  <cp:lastModifiedBy>Ehab Mansour</cp:lastModifiedBy>
  <cp:revision>9</cp:revision>
  <dcterms:created xsi:type="dcterms:W3CDTF">2021-10-13T12:04:47Z</dcterms:created>
  <dcterms:modified xsi:type="dcterms:W3CDTF">2021-10-17T14:30:16Z</dcterms:modified>
</cp:coreProperties>
</file>